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394" r:id="rId2"/>
    <p:sldId id="326" r:id="rId3"/>
  </p:sldIdLst>
  <p:sldSz cx="6858000" cy="9144000" type="screen4x3"/>
  <p:notesSz cx="7010400" cy="9296400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4">
          <p15:clr>
            <a:srgbClr val="A4A3A4"/>
          </p15:clr>
        </p15:guide>
        <p15:guide id="2" pos="225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istrator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1" d="100"/>
          <a:sy n="81" d="100"/>
        </p:scale>
        <p:origin x="3762" y="246"/>
      </p:cViewPr>
      <p:guideLst>
        <p:guide orient="horz" pos="2724"/>
        <p:guide pos="225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tags" Target="tags/tag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700" cy="4664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755" y="0"/>
            <a:ext cx="3037700" cy="4664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008" y="4473751"/>
            <a:ext cx="5608061" cy="36603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86"/>
            <a:ext cx="3037700" cy="4664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755" y="8829686"/>
            <a:ext cx="3037700" cy="4664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8D9BD-0321-4156-96A3-DF4B32A00472}" type="datetimeFigureOut">
              <a:rPr lang="zh-CN" altLang="en-US" smtClean="0"/>
              <a:t>2023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5A0E2-7524-4CC4-B061-AC113D9EC4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3743913" name="矩形 11"/>
          <p:cNvSpPr>
            <a:spLocks noRot="1"/>
          </p:cNvSpPr>
          <p:nvPr/>
        </p:nvSpPr>
        <p:spPr>
          <a:xfrm>
            <a:off x="205105" y="7858760"/>
            <a:ext cx="6447155" cy="961710"/>
          </a:xfrm>
          <a:prstGeom prst="rect">
            <a:avLst/>
          </a:prstGeom>
          <a:noFill/>
          <a:ln w="9525">
            <a:noFill/>
          </a:ln>
        </p:spPr>
        <p:txBody>
          <a:bodyPr wrap="square"/>
          <a:lstStyle/>
          <a:p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l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. SAG114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AT5G25110)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nRK3.25 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s a typical protein of SnRK family.</a:t>
            </a:r>
            <a:r>
              <a:rPr lang="zh-CN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ylogenetic tree of SnRK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A neighbor-joining tree was built on the full length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mino acid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quences. B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agram of 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ucture of SnRK3s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 for amino-terminus and C for carboxyl terminus.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C2D8AF66-12E2-4CB9-A4FF-8DB2319395ED}"/>
              </a:ext>
            </a:extLst>
          </p:cNvPr>
          <p:cNvGrpSpPr/>
          <p:nvPr/>
        </p:nvGrpSpPr>
        <p:grpSpPr>
          <a:xfrm>
            <a:off x="701040" y="2123028"/>
            <a:ext cx="5210026" cy="4681220"/>
            <a:chOff x="701040" y="1467485"/>
            <a:chExt cx="5210026" cy="4681220"/>
          </a:xfrm>
        </p:grpSpPr>
        <p:sp>
          <p:nvSpPr>
            <p:cNvPr id="3" name="文本框 2"/>
            <p:cNvSpPr txBox="1"/>
            <p:nvPr/>
          </p:nvSpPr>
          <p:spPr>
            <a:xfrm>
              <a:off x="701040" y="1467485"/>
              <a:ext cx="54419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3" name="组合 12"/>
            <p:cNvGrpSpPr/>
            <p:nvPr/>
          </p:nvGrpSpPr>
          <p:grpSpPr>
            <a:xfrm>
              <a:off x="942975" y="5184775"/>
              <a:ext cx="4130675" cy="873760"/>
              <a:chOff x="3656" y="6914"/>
              <a:chExt cx="6505" cy="1376"/>
            </a:xfrm>
          </p:grpSpPr>
          <p:cxnSp>
            <p:nvCxnSpPr>
              <p:cNvPr id="4" name="直接连接符 3"/>
              <p:cNvCxnSpPr/>
              <p:nvPr/>
            </p:nvCxnSpPr>
            <p:spPr>
              <a:xfrm>
                <a:off x="4880" y="7957"/>
                <a:ext cx="585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直接连接符 4"/>
              <p:cNvCxnSpPr/>
              <p:nvPr/>
            </p:nvCxnSpPr>
            <p:spPr>
              <a:xfrm>
                <a:off x="7344" y="7957"/>
                <a:ext cx="585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接连接符 5"/>
              <p:cNvCxnSpPr/>
              <p:nvPr/>
            </p:nvCxnSpPr>
            <p:spPr>
              <a:xfrm>
                <a:off x="9325" y="7957"/>
                <a:ext cx="585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矩形 8"/>
              <p:cNvSpPr/>
              <p:nvPr/>
            </p:nvSpPr>
            <p:spPr>
              <a:xfrm>
                <a:off x="7911" y="7624"/>
                <a:ext cx="1414" cy="66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AF</a:t>
                </a:r>
              </a:p>
              <a:p>
                <a:pPr algn="ctr"/>
                <a:r>
                  <a:rPr lang="en-US" altLang="zh-CN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4697" y="7377"/>
                <a:ext cx="476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9685" y="7399"/>
                <a:ext cx="476" cy="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3656" y="6914"/>
                <a:ext cx="476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14" name="矩形 13"/>
            <p:cNvSpPr/>
            <p:nvPr/>
          </p:nvSpPr>
          <p:spPr>
            <a:xfrm>
              <a:off x="2091055" y="5475605"/>
              <a:ext cx="1193800" cy="673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er/</a:t>
              </a:r>
              <a:r>
                <a:rPr lang="en-US" altLang="zh-CN" sz="14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Thr</a:t>
              </a:r>
              <a:endPara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inase domain </a:t>
              </a:r>
              <a:endPara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55CC3277-A0CE-4501-84DA-9B73187EADAA}"/>
                </a:ext>
              </a:extLst>
            </p:cNvPr>
            <p:cNvGrpSpPr/>
            <p:nvPr/>
          </p:nvGrpSpPr>
          <p:grpSpPr>
            <a:xfrm>
              <a:off x="1497685" y="1837105"/>
              <a:ext cx="4413381" cy="3371409"/>
              <a:chOff x="1497685" y="1837105"/>
              <a:chExt cx="4413381" cy="3371409"/>
            </a:xfrm>
          </p:grpSpPr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051EAF1D-19EC-4475-85C5-951A1EB488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97685" y="1837105"/>
                <a:ext cx="3457855" cy="3371409"/>
              </a:xfrm>
              <a:prstGeom prst="rect">
                <a:avLst/>
              </a:prstGeom>
            </p:spPr>
          </p:pic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AE1BD891-8B2A-4CA6-98C7-A5568BB0000C}"/>
                  </a:ext>
                </a:extLst>
              </p:cNvPr>
              <p:cNvSpPr/>
              <p:nvPr/>
            </p:nvSpPr>
            <p:spPr>
              <a:xfrm>
                <a:off x="5013176" y="1865919"/>
                <a:ext cx="897890" cy="2159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 I</a:t>
                </a: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7C38A033-CEC1-4E91-93B9-B9926969A5CD}"/>
                  </a:ext>
                </a:extLst>
              </p:cNvPr>
              <p:cNvSpPr/>
              <p:nvPr/>
            </p:nvSpPr>
            <p:spPr>
              <a:xfrm>
                <a:off x="5013176" y="2496330"/>
                <a:ext cx="897890" cy="2159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 II</a:t>
                </a: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E9E3C300-E57E-44B8-92BC-14BC285BD7B7}"/>
                  </a:ext>
                </a:extLst>
              </p:cNvPr>
              <p:cNvSpPr/>
              <p:nvPr/>
            </p:nvSpPr>
            <p:spPr>
              <a:xfrm>
                <a:off x="5013176" y="3863629"/>
                <a:ext cx="897890" cy="2159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oup III</a:t>
                </a:r>
              </a:p>
            </p:txBody>
          </p: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CBE88F6F-0EA9-E3CB-CF87-017F7BC5166E}"/>
              </a:ext>
            </a:extLst>
          </p:cNvPr>
          <p:cNvSpPr/>
          <p:nvPr/>
        </p:nvSpPr>
        <p:spPr>
          <a:xfrm>
            <a:off x="4625439" y="4643458"/>
            <a:ext cx="334112" cy="91650"/>
          </a:xfrm>
          <a:prstGeom prst="rect">
            <a:avLst/>
          </a:prstGeom>
          <a:noFill/>
          <a:ln w="127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246A173-04B4-448D-A3B1-6CA836E2C445}"/>
              </a:ext>
            </a:extLst>
          </p:cNvPr>
          <p:cNvSpPr txBox="1"/>
          <p:nvPr/>
        </p:nvSpPr>
        <p:spPr>
          <a:xfrm>
            <a:off x="1715219" y="395536"/>
            <a:ext cx="3430436" cy="4630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Information</a:t>
            </a:r>
            <a:endParaRPr lang="en-US" sz="1400" kern="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0439601-6F02-99F2-AB84-FAC05061C23F}"/>
              </a:ext>
            </a:extLst>
          </p:cNvPr>
          <p:cNvGrpSpPr/>
          <p:nvPr/>
        </p:nvGrpSpPr>
        <p:grpSpPr>
          <a:xfrm>
            <a:off x="764704" y="1846580"/>
            <a:ext cx="5342255" cy="4501515"/>
            <a:chOff x="1095375" y="1846580"/>
            <a:chExt cx="5342255" cy="4501515"/>
          </a:xfrm>
        </p:grpSpPr>
        <p:pic>
          <p:nvPicPr>
            <p:cNvPr id="4" name="图片 3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1095375" y="4187825"/>
              <a:ext cx="2520315" cy="2160270"/>
            </a:xfrm>
            <a:prstGeom prst="rect">
              <a:avLst/>
            </a:prstGeom>
          </p:spPr>
        </p:pic>
        <p:pic>
          <p:nvPicPr>
            <p:cNvPr id="5" name="图片 4"/>
            <p:cNvPicPr/>
            <p:nvPr/>
          </p:nvPicPr>
          <p:blipFill>
            <a:blip r:embed="rId3"/>
            <a:stretch>
              <a:fillRect/>
            </a:stretch>
          </p:blipFill>
          <p:spPr>
            <a:xfrm>
              <a:off x="1095375" y="1846580"/>
              <a:ext cx="2520315" cy="2160270"/>
            </a:xfrm>
            <a:prstGeom prst="rect">
              <a:avLst/>
            </a:prstGeom>
          </p:spPr>
        </p:pic>
        <p:pic>
          <p:nvPicPr>
            <p:cNvPr id="6" name="图片 5"/>
            <p:cNvPicPr/>
            <p:nvPr/>
          </p:nvPicPr>
          <p:blipFill>
            <a:blip r:embed="rId4"/>
            <a:stretch>
              <a:fillRect/>
            </a:stretch>
          </p:blipFill>
          <p:spPr>
            <a:xfrm>
              <a:off x="3917315" y="1846580"/>
              <a:ext cx="2520315" cy="2160270"/>
            </a:xfrm>
            <a:prstGeom prst="rect">
              <a:avLst/>
            </a:prstGeom>
          </p:spPr>
        </p:pic>
        <p:pic>
          <p:nvPicPr>
            <p:cNvPr id="7" name="图片 6"/>
            <p:cNvPicPr/>
            <p:nvPr/>
          </p:nvPicPr>
          <p:blipFill>
            <a:blip r:embed="rId5"/>
            <a:stretch>
              <a:fillRect/>
            </a:stretch>
          </p:blipFill>
          <p:spPr>
            <a:xfrm>
              <a:off x="3916680" y="4187825"/>
              <a:ext cx="2520315" cy="216027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1746250" y="1846580"/>
              <a:ext cx="14478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g114- ML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746250" y="4187825"/>
              <a:ext cx="14478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g114- ES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613910" y="4187825"/>
              <a:ext cx="14478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- ES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453255" y="1846580"/>
              <a:ext cx="14478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- ML</a:t>
              </a:r>
            </a:p>
          </p:txBody>
        </p:sp>
      </p:grpSp>
      <p:sp>
        <p:nvSpPr>
          <p:cNvPr id="1073743905" name="文本框 2"/>
          <p:cNvSpPr txBox="1">
            <a:spLocks noRot="1"/>
          </p:cNvSpPr>
          <p:nvPr/>
        </p:nvSpPr>
        <p:spPr>
          <a:xfrm>
            <a:off x="203200" y="6825615"/>
            <a:ext cx="6452235" cy="914737"/>
          </a:xfrm>
          <a:prstGeom prst="rect">
            <a:avLst/>
          </a:prstGeom>
          <a:noFill/>
          <a:ln w="9525">
            <a:noFill/>
          </a:ln>
        </p:spPr>
        <p:txBody>
          <a:bodyPr vert="horz" wrap="square" anchor="t"/>
          <a:lstStyle/>
          <a:p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upplement Figur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2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mata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perture in </a:t>
            </a:r>
            <a:r>
              <a:rPr lang="zh-CN" alt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ag114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s larger than that of WT in both mature leaves and senescing leaves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g114-ML, mature leaves in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g114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nockout lines. sag114-ES, early senescence leaves in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g11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knockout lines. WT-ML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mature leaves in wild type Arabidopsis plants. WT-ES, early senescence leaves in wild type Arabidopsis plants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OC_GUID" val="{c65c7dd0-f86a-4984-871a-d78e6457f2a4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 lang="zh-CN" altLang="en-US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4</TotalTime>
  <Words>156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LL</dc:creator>
  <cp:lastModifiedBy>Susheng Gan</cp:lastModifiedBy>
  <cp:revision>1166</cp:revision>
  <cp:lastPrinted>2021-08-05T20:52:00Z</cp:lastPrinted>
  <dcterms:created xsi:type="dcterms:W3CDTF">2015-12-21T06:16:00Z</dcterms:created>
  <dcterms:modified xsi:type="dcterms:W3CDTF">2023-10-10T17:00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64</vt:lpwstr>
  </property>
</Properties>
</file>